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725"/>
  </p:normalViewPr>
  <p:slideViewPr>
    <p:cSldViewPr snapToGrid="0">
      <p:cViewPr varScale="1">
        <p:scale>
          <a:sx n="107" d="100"/>
          <a:sy n="107" d="100"/>
        </p:scale>
        <p:origin x="64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A25016-E94C-5655-602D-D559C000EF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FB0CC7-3CE2-8B19-0190-6CAF27EE6F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845CF6-9752-3E95-7434-DA34651F5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C236A1-2A9F-A33E-F406-03EFB98B1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113008-0218-E4A6-9EF9-5871921CC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485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51271F-CB78-E3CB-DF3C-74B7035EA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A7A816-D100-5194-1069-72D2B284EB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9649DF-CEF2-0499-D404-A67A4EF09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B04FB4-84B0-20AE-BBFF-0189641C4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9EFCA8-F73A-6E9D-646C-186B5147B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191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A24F50-389E-B16A-2FAE-A07F64D85F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038E3D-5A51-87A5-9D19-21B49DF446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F67E02-85EF-3B32-33C5-CE164C3B3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A0A568-DD8C-095D-4055-3FBDC60C6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3D49C8-038E-B7DE-059A-CFAFB6FDC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19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B42DB-641C-1841-C9BF-BD390F7730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F9B5EC-1CD2-FF34-C1EE-182C2F2AB9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4145E7-CA46-C8FA-334D-042BFE6B6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431711-BAB7-3DDC-35F7-212FDBED5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E19E53-4B46-6A24-42A0-AE53E50EF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330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A0E96-B4A4-D853-87B7-1B39A44DAE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E8A68E-5C02-AA1F-8F4F-CE781DECF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BBF08B-3532-2775-1879-C61D9F5C7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CE47B-FF6A-2623-97C6-73D0B9198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232FD5-680E-16AF-6728-2DD747F14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330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97E3F-6D1B-8626-412A-63ED74FDD9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ADEE7A-EAD2-8B79-6D55-A0DF033BBC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49DF55-5A94-94FA-9768-7802CF58D9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7485C3-57EA-DC31-1776-E6B74EBEB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402F2A-1D13-72F3-DD1B-3143E968E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921FF9-3966-90DB-1010-A07BAC600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599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DC313-94F5-3187-5E37-90C258B82A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C079A9-6C39-4D06-51E6-92A2B7649C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334F21-F27C-DCEF-3262-8E09B343E1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7BF600-3298-539F-F244-63A4BDC21B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63E4E2-AFEB-7BF7-CD06-C540AC81C8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99C154-E3A3-B8AE-68C5-075902ED1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8B3795-9FBE-16A8-36C8-F0D785B5B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C9AA60-D003-FBFF-1440-896FB673F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947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F465F7-317B-789F-A51C-0D39D5EF0D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AA76B4-A235-22D6-D188-BF66B280D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36EEC7-27FD-9E0E-4F7F-2AC3829F5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D511E8-0FF8-1784-B2D6-FA2E22148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983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3CE8EF-D909-DBE2-2E17-E44BC08B2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B7FBBE8-2FC3-FB32-992C-3A858C3FD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3E998C-3DA3-7120-12E9-52F14C858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112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511C8-1CF4-2D37-1905-2565707F4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FF154D-44AE-A57C-49D0-C8D52BD8E7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76F98F-5277-26B0-C488-8E2A1F9901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4647A2-B5FA-614D-2F18-AF34FDB18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85F2E2-D966-F373-C29C-9934A1E97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67BA02-06B3-0247-FFAC-026DF7355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36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5E892-5484-6475-FB2E-CC716600DF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30560D-0C70-4FD2-52C7-3433F23524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979450-30F6-F6EB-6D3A-595378E1B6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575E4A-47EE-2FA6-3538-0A50A8A1A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933406-11FB-AF71-147A-A5DD69623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066DD5-52B3-7418-DF6A-671E4D2F1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136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ACA03E-727E-9CBA-7F13-AF1B0010DF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942008-2A09-9ED3-1794-1493CB533D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4A866F-E740-15E1-7E62-70D4EF2245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516FFA-1C2A-0044-A007-A4F8F9630AD4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0D344-6B12-3DEE-CFCB-3D203E2C95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EFAE4-1F0F-5002-7C9D-52D5DC56BC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4307D7-5E40-D943-81D4-5ED0915A6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698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B25B353-BC00-3A3A-6B5E-EDBB8669896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2229" y="148879"/>
            <a:ext cx="7785382" cy="4792811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211BAC7-8313-2E7D-E07D-68D962E0D1E8}"/>
              </a:ext>
            </a:extLst>
          </p:cNvPr>
          <p:cNvSpPr txBox="1"/>
          <p:nvPr/>
        </p:nvSpPr>
        <p:spPr>
          <a:xfrm>
            <a:off x="753613" y="5401914"/>
            <a:ext cx="106847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hematic of known molecules involved in </a:t>
            </a:r>
            <a:r>
              <a:rPr lang="en-GB" sz="1200" b="1" i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GF-A 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ternative 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icing. </a:t>
            </a:r>
          </a:p>
          <a:p>
            <a:pPr algn="just"/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S: proximal splice site; DSS: distal splice site.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eated with information from M. Stevens et al. </a:t>
            </a:r>
            <a:r>
              <a:rPr lang="en-US" sz="1200" i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2018), G. </a:t>
            </a:r>
            <a:r>
              <a:rPr lang="en-US" sz="1200" dirty="0" err="1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rdzhanova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t al. </a:t>
            </a:r>
            <a:r>
              <a:rPr lang="en-US" sz="1200" i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cogene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2010), and R. Kikuchi et al. </a:t>
            </a:r>
            <a:r>
              <a:rPr lang="en-US" sz="1200" i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Med 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2014). Created with </a:t>
            </a:r>
            <a:r>
              <a:rPr lang="en-US" sz="1200" dirty="0" err="1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oRender.com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solidFill>
                <a:srgbClr val="0D0D0D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75880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6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ltean, Seb</dc:creator>
  <cp:lastModifiedBy>Author</cp:lastModifiedBy>
  <cp:revision>10</cp:revision>
  <dcterms:created xsi:type="dcterms:W3CDTF">2025-04-30T09:50:42Z</dcterms:created>
  <dcterms:modified xsi:type="dcterms:W3CDTF">2025-10-03T11:14:25Z</dcterms:modified>
</cp:coreProperties>
</file>